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fzdewey\AppData\Local\Microsoft\Windows\INetCache\Content.Outlook\MZ2CHW72\mqlns%20meta-analysis_rob_2023-05-10_agree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Figure!$B$2</c:f>
              <c:strCache>
                <c:ptCount val="1"/>
                <c:pt idx="0">
                  <c:v>High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rgbClr val="FF0000"/>
              </a:solidFill>
            </a:ln>
            <a:effectLst/>
          </c:spPr>
          <c:invertIfNegative val="0"/>
          <c:cat>
            <c:strRef>
              <c:f>Figure!$A$3:$A$9</c:f>
              <c:strCache>
                <c:ptCount val="7"/>
                <c:pt idx="0">
                  <c:v>Random sequence generation</c:v>
                </c:pt>
                <c:pt idx="1">
                  <c:v>Allocation concealment</c:v>
                </c:pt>
                <c:pt idx="2">
                  <c:v>Blinding participants</c:v>
                </c:pt>
                <c:pt idx="3">
                  <c:v>Blinding outcome assessment</c:v>
                </c:pt>
                <c:pt idx="4">
                  <c:v>Incomplete outcome</c:v>
                </c:pt>
                <c:pt idx="5">
                  <c:v>Selective reporting</c:v>
                </c:pt>
                <c:pt idx="6">
                  <c:v>Other</c:v>
                </c:pt>
              </c:strCache>
            </c:strRef>
          </c:cat>
          <c:val>
            <c:numRef>
              <c:f>Figure!$B$3:$B$9</c:f>
              <c:numCache>
                <c:formatCode>0%</c:formatCode>
                <c:ptCount val="7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0.625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E9-4420-8704-189F80D95A82}"/>
            </c:ext>
          </c:extLst>
        </c:ser>
        <c:ser>
          <c:idx val="1"/>
          <c:order val="1"/>
          <c:tx>
            <c:strRef>
              <c:f>Figure!$C$2</c:f>
              <c:strCache>
                <c:ptCount val="1"/>
                <c:pt idx="0">
                  <c:v>Unclea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Figure!$A$3:$A$9</c:f>
              <c:strCache>
                <c:ptCount val="7"/>
                <c:pt idx="0">
                  <c:v>Random sequence generation</c:v>
                </c:pt>
                <c:pt idx="1">
                  <c:v>Allocation concealment</c:v>
                </c:pt>
                <c:pt idx="2">
                  <c:v>Blinding participants</c:v>
                </c:pt>
                <c:pt idx="3">
                  <c:v>Blinding outcome assessment</c:v>
                </c:pt>
                <c:pt idx="4">
                  <c:v>Incomplete outcome</c:v>
                </c:pt>
                <c:pt idx="5">
                  <c:v>Selective reporting</c:v>
                </c:pt>
                <c:pt idx="6">
                  <c:v>Other</c:v>
                </c:pt>
              </c:strCache>
            </c:strRef>
          </c:cat>
          <c:val>
            <c:numRef>
              <c:f>Figure!$C$3:$C$9</c:f>
              <c:numCache>
                <c:formatCode>0%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5E9-4420-8704-189F80D95A82}"/>
            </c:ext>
          </c:extLst>
        </c:ser>
        <c:ser>
          <c:idx val="2"/>
          <c:order val="2"/>
          <c:tx>
            <c:strRef>
              <c:f>Figure!$D$2</c:f>
              <c:strCache>
                <c:ptCount val="1"/>
                <c:pt idx="0">
                  <c:v>Low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rgbClr val="00B050"/>
              </a:solidFill>
            </a:ln>
            <a:effectLst/>
          </c:spPr>
          <c:invertIfNegative val="0"/>
          <c:cat>
            <c:strRef>
              <c:f>Figure!$A$3:$A$9</c:f>
              <c:strCache>
                <c:ptCount val="7"/>
                <c:pt idx="0">
                  <c:v>Random sequence generation</c:v>
                </c:pt>
                <c:pt idx="1">
                  <c:v>Allocation concealment</c:v>
                </c:pt>
                <c:pt idx="2">
                  <c:v>Blinding participants</c:v>
                </c:pt>
                <c:pt idx="3">
                  <c:v>Blinding outcome assessment</c:v>
                </c:pt>
                <c:pt idx="4">
                  <c:v>Incomplete outcome</c:v>
                </c:pt>
                <c:pt idx="5">
                  <c:v>Selective reporting</c:v>
                </c:pt>
                <c:pt idx="6">
                  <c:v>Other</c:v>
                </c:pt>
              </c:strCache>
            </c:strRef>
          </c:cat>
          <c:val>
            <c:numRef>
              <c:f>Figure!$D$3:$D$9</c:f>
              <c:numCache>
                <c:formatCode>0%</c:formatCode>
                <c:ptCount val="7"/>
                <c:pt idx="0">
                  <c:v>1</c:v>
                </c:pt>
                <c:pt idx="1">
                  <c:v>1</c:v>
                </c:pt>
                <c:pt idx="2">
                  <c:v>0</c:v>
                </c:pt>
                <c:pt idx="3">
                  <c:v>0.375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5E9-4420-8704-189F80D95A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77104488"/>
        <c:axId val="593254064"/>
      </c:barChart>
      <c:catAx>
        <c:axId val="377104488"/>
        <c:scaling>
          <c:orientation val="maxMin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93254064"/>
        <c:crosses val="autoZero"/>
        <c:auto val="1"/>
        <c:lblAlgn val="ctr"/>
        <c:lblOffset val="100"/>
        <c:noMultiLvlLbl val="0"/>
      </c:catAx>
      <c:valAx>
        <c:axId val="593254064"/>
        <c:scaling>
          <c:orientation val="minMax"/>
          <c:max val="1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77104488"/>
        <c:crosses val="max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egendEntry>
        <c:idx val="2"/>
        <c:txPr>
          <a:bodyPr rot="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</c:legendEntry>
      <c:layout>
        <c:manualLayout>
          <c:xMode val="edge"/>
          <c:yMode val="edge"/>
          <c:x val="0.30643320736104462"/>
          <c:y val="0.9448477642731975"/>
          <c:w val="0.34902271675113167"/>
          <c:h val="4.254607848256012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01A346-3B49-4A29-AD29-5E0E2CC2714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24FA54A-D643-4C2B-8CB4-EBA292C3800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29622F-0502-4F67-8E9E-635A69B34D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464B9-FB00-48D0-A980-B9D5A0CD3F68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2A1CE2-9F23-49D0-8B51-3BD685BA14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02B883-473C-4122-A89C-9B63FE8543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F8F49-FE69-4A0F-B68F-C366BB339C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17291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650D82-A08A-4A39-B0A0-ABF38D108E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A322866-49FC-4048-B526-2A93AFD965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B5C70C-2013-435A-95BC-5C1DF297BC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464B9-FB00-48D0-A980-B9D5A0CD3F68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5B4E72-BA1C-488B-9804-ACA9D42285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C45BE3-66EE-4C3B-9DE7-D586CBEAA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F8F49-FE69-4A0F-B68F-C366BB339C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1122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F6CC16C-97D7-4885-B84C-A5E0869DE7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082842-821A-4B89-9737-FE2AAB4D6D9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605CD8-50AF-462B-9BCC-610731F24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464B9-FB00-48D0-A980-B9D5A0CD3F68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D6129E-8677-46F4-91C3-0D972CAF78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F91DFA-2E0F-4137-A9F3-14E7015067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F8F49-FE69-4A0F-B68F-C366BB339C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5527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098763-E3A6-4BDB-9870-D7DEE4EE36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8148EB-0E44-4D45-99AB-F1AF4E213B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788FDC-0001-4577-B1D2-2FF9433A8A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464B9-FB00-48D0-A980-B9D5A0CD3F68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840224-36F0-46EF-A5B9-114204A69F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502AD5-1708-43A0-82E7-3B67417CF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F8F49-FE69-4A0F-B68F-C366BB339C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9459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753D57-5FC6-4CE5-9682-A169DFC26A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FD660D-4E00-4EBD-96A6-A4A5ADE978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177AD3-69C6-43BC-984F-19419DB181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464B9-FB00-48D0-A980-B9D5A0CD3F68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9FAC07-BDAB-4E0E-8FF6-E8E22F2865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6B6506-5F69-4588-BD4C-EC63F5653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F8F49-FE69-4A0F-B68F-C366BB339C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588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FCDF72-7E2B-4B26-BB9B-ED55F7B025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10EECE-9A5A-45B9-976F-828AC0C0E3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8119342-222D-42BF-9CA1-435C86282A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C142C3-AC49-4532-9BA3-A09631492E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464B9-FB00-48D0-A980-B9D5A0CD3F68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1C5857-574E-4D20-8574-8892BFAE57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9FBE71-A25A-41F9-BAE2-DEDAFF470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F8F49-FE69-4A0F-B68F-C366BB339C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899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9A68B8-43C0-429E-9875-B5234DEBAD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92CFE9-8C46-4D7B-A6B1-F2918C1F9E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898D8F-7730-415B-A6F0-7775A2EA31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577EFFD-BEE5-4E79-9834-6332F8CB94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33DF475-978D-4012-BAFD-6F3262999E5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50FFAFD-9684-4109-B23F-6C8F0541AF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464B9-FB00-48D0-A980-B9D5A0CD3F68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DF0F54F-5F4C-4ABB-BDCE-479DF33F7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8E11DBF-51DC-42E5-B7DF-B54CD0963C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F8F49-FE69-4A0F-B68F-C366BB339C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400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806C0D-8509-430C-BF2B-700758D48E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0C27CCB-17FB-4309-B1F9-7B46647604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464B9-FB00-48D0-A980-B9D5A0CD3F68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62C448A-32A7-46F5-8FB8-03E0935AC2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B160E91-72A1-4204-96FC-8C26D8797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F8F49-FE69-4A0F-B68F-C366BB339C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352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6C5005F-00C9-4A87-9998-9016518B48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464B9-FB00-48D0-A980-B9D5A0CD3F68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4133332-FF17-4BCE-A10A-30E80F5B03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5D45511-8538-4936-A119-5A53864B8E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F8F49-FE69-4A0F-B68F-C366BB339C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869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96D204-2EF0-4D09-8D46-351685A9AC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68655D-9FDA-4829-9F5A-CCC75AB3C3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11673BB-F183-43D1-864E-E103ACB520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A7FBA7-1EEB-4331-90C0-99FF17E83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464B9-FB00-48D0-A980-B9D5A0CD3F68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B3F6CD-85FC-47C6-B471-238216A508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3DD18B-AF88-4BFA-8689-A69302DDB4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F8F49-FE69-4A0F-B68F-C366BB339C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8671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3586DC-1AB9-4BF8-AF90-E28F38B23A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748C38B-76DD-4BFE-A9A1-2CD1D473A3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914CD21-D549-48D0-993A-E07A68BF51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171767-4521-4D58-A775-4B4542BFB7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464B9-FB00-48D0-A980-B9D5A0CD3F68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42554A-5166-4123-88E1-AA63BB0DE6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49591D-9418-468F-93C9-623E7A198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3F8F49-FE69-4A0F-B68F-C366BB339C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77471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7581DEB-A700-4F0D-A1F6-B82037F275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58EDC5-4410-4600-AB68-B6687EBEF5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58E325-E8FA-40E6-9E65-AE8BD26172D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0464B9-FB00-48D0-A980-B9D5A0CD3F68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EE4338-C231-4287-803E-13694011C9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0248F3-A382-4E9E-9466-3FDA0AB18E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3F8F49-FE69-4A0F-B68F-C366BB339C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479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DC0FFE3C-118C-F192-A79B-CEB4A00E981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46284161"/>
              </p:ext>
            </p:extLst>
          </p:nvPr>
        </p:nvGraphicFramePr>
        <p:xfrm>
          <a:off x="2582779" y="1018673"/>
          <a:ext cx="7331242" cy="50372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955881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Office PowerPoint</Application>
  <PresentationFormat>Widescreen</PresentationFormat>
  <Paragraphs>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hryn Dewey</dc:creator>
  <cp:lastModifiedBy>Kathryn Dewey</cp:lastModifiedBy>
  <cp:revision>1</cp:revision>
  <dcterms:created xsi:type="dcterms:W3CDTF">2023-05-24T20:48:18Z</dcterms:created>
  <dcterms:modified xsi:type="dcterms:W3CDTF">2023-05-24T20:49:13Z</dcterms:modified>
</cp:coreProperties>
</file>